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96" r:id="rId2"/>
    <p:sldId id="306" r:id="rId3"/>
  </p:sldIdLst>
  <p:sldSz cx="12192000" cy="1079976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upplementary" id="{58C11A2C-8F96-4E99-B972-EC79F8444009}">
          <p14:sldIdLst>
            <p14:sldId id="296"/>
            <p14:sldId id="306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ee Yonggu" initials="LY" lastIdx="1" clrIdx="0">
    <p:extLst>
      <p:ext uri="{19B8F6BF-5375-455C-9EA6-DF929625EA0E}">
        <p15:presenceInfo xmlns:p15="http://schemas.microsoft.com/office/powerpoint/2012/main" userId="09b23e8a4ed0efb5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7373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6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2252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767462"/>
            <a:ext cx="10363200" cy="375991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5672376"/>
            <a:ext cx="9144000" cy="2607442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21064-0088-43A4-9A2A-F741CFB538FA}" type="datetimeFigureOut">
              <a:rPr lang="ko-KR" altLang="en-US" smtClean="0"/>
              <a:t>2021-08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047FE-C59F-40ED-8DC2-188EF47AC8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399101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21064-0088-43A4-9A2A-F741CFB538FA}" type="datetimeFigureOut">
              <a:rPr lang="ko-KR" altLang="en-US" smtClean="0"/>
              <a:t>2021-08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047FE-C59F-40ED-8DC2-188EF47AC8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35253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574987"/>
            <a:ext cx="2628900" cy="9152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574987"/>
            <a:ext cx="7734300" cy="9152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21064-0088-43A4-9A2A-F741CFB538FA}" type="datetimeFigureOut">
              <a:rPr lang="ko-KR" altLang="en-US" smtClean="0"/>
              <a:t>2021-08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047FE-C59F-40ED-8DC2-188EF47AC8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908980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21064-0088-43A4-9A2A-F741CFB538FA}" type="datetimeFigureOut">
              <a:rPr lang="ko-KR" altLang="en-US" smtClean="0"/>
              <a:t>2021-08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047FE-C59F-40ED-8DC2-188EF47AC8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683681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692444"/>
            <a:ext cx="10515600" cy="4492401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7227345"/>
            <a:ext cx="10515600" cy="2362447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21064-0088-43A4-9A2A-F741CFB538FA}" type="datetimeFigureOut">
              <a:rPr lang="ko-KR" altLang="en-US" smtClean="0"/>
              <a:t>2021-08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047FE-C59F-40ED-8DC2-188EF47AC8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54027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874937"/>
            <a:ext cx="5181600" cy="6852350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874937"/>
            <a:ext cx="5181600" cy="6852350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21064-0088-43A4-9A2A-F741CFB538FA}" type="datetimeFigureOut">
              <a:rPr lang="ko-KR" altLang="en-US" smtClean="0"/>
              <a:t>2021-08-0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047FE-C59F-40ED-8DC2-188EF47AC8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716621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74990"/>
            <a:ext cx="10515600" cy="208745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647443"/>
            <a:ext cx="5157787" cy="1297471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944914"/>
            <a:ext cx="5157787" cy="580237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647443"/>
            <a:ext cx="5183188" cy="1297471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944914"/>
            <a:ext cx="5183188" cy="580237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21064-0088-43A4-9A2A-F741CFB538FA}" type="datetimeFigureOut">
              <a:rPr lang="ko-KR" altLang="en-US" smtClean="0"/>
              <a:t>2021-08-0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047FE-C59F-40ED-8DC2-188EF47AC8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237968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21064-0088-43A4-9A2A-F741CFB538FA}" type="datetimeFigureOut">
              <a:rPr lang="ko-KR" altLang="en-US" smtClean="0"/>
              <a:t>2021-08-0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047FE-C59F-40ED-8DC2-188EF47AC8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248408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21064-0088-43A4-9A2A-F741CFB538FA}" type="datetimeFigureOut">
              <a:rPr lang="ko-KR" altLang="en-US" smtClean="0"/>
              <a:t>2021-08-0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047FE-C59F-40ED-8DC2-188EF47AC8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50323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19984"/>
            <a:ext cx="3932237" cy="2519945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554968"/>
            <a:ext cx="6172200" cy="7674832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239929"/>
            <a:ext cx="3932237" cy="6002369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21064-0088-43A4-9A2A-F741CFB538FA}" type="datetimeFigureOut">
              <a:rPr lang="ko-KR" altLang="en-US" smtClean="0"/>
              <a:t>2021-08-0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047FE-C59F-40ED-8DC2-188EF47AC8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452325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19984"/>
            <a:ext cx="3932237" cy="2519945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554968"/>
            <a:ext cx="6172200" cy="7674832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239929"/>
            <a:ext cx="3932237" cy="6002369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21064-0088-43A4-9A2A-F741CFB538FA}" type="datetimeFigureOut">
              <a:rPr lang="ko-KR" altLang="en-US" smtClean="0"/>
              <a:t>2021-08-0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047FE-C59F-40ED-8DC2-188EF47AC8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886966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574990"/>
            <a:ext cx="10515600" cy="2087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874937"/>
            <a:ext cx="10515600" cy="68523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0009783"/>
            <a:ext cx="2743200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D21064-0088-43A4-9A2A-F741CFB538FA}" type="datetimeFigureOut">
              <a:rPr lang="ko-KR" altLang="en-US" smtClean="0"/>
              <a:t>2021-08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0009783"/>
            <a:ext cx="4114800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0009783"/>
            <a:ext cx="2743200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3047FE-C59F-40ED-8DC2-188EF47AC8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5602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7" Type="http://schemas.openxmlformats.org/officeDocument/2006/relationships/image" Target="../media/image8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emf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2"/>
          <a:srcRect l="3653" b="7251"/>
          <a:stretch/>
        </p:blipFill>
        <p:spPr>
          <a:xfrm>
            <a:off x="6116128" y="3410927"/>
            <a:ext cx="4624663" cy="329585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7333755" y="4329198"/>
            <a:ext cx="11913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P &lt;0.001</a:t>
            </a:r>
          </a:p>
          <a:p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Non-linear p&lt;0.001</a:t>
            </a:r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 rotWithShape="1">
          <a:blip r:embed="rId3"/>
          <a:srcRect l="4367" b="8448"/>
          <a:stretch/>
        </p:blipFill>
        <p:spPr>
          <a:xfrm>
            <a:off x="1259456" y="3410927"/>
            <a:ext cx="4590380" cy="3295856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308268" y="4372330"/>
            <a:ext cx="11913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P &lt;0.001</a:t>
            </a:r>
          </a:p>
          <a:p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Non-linear p&lt;0.001</a:t>
            </a:r>
          </a:p>
        </p:txBody>
      </p:sp>
      <p:sp>
        <p:nvSpPr>
          <p:cNvPr id="8" name="TextBox 7"/>
          <p:cNvSpPr txBox="1"/>
          <p:nvPr/>
        </p:nvSpPr>
        <p:spPr>
          <a:xfrm rot="16200000">
            <a:off x="-271149" y="4897463"/>
            <a:ext cx="21593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Absolute bias </a:t>
            </a:r>
          </a:p>
          <a:p>
            <a:pPr algn="ctr"/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between radar and </a:t>
            </a:r>
            <a:r>
              <a:rPr lang="en-US" sz="1200" dirty="0" err="1" smtClean="0">
                <a:latin typeface="Calibri" panose="020F0502020204030204" pitchFamily="34" charset="0"/>
                <a:cs typeface="Calibri" panose="020F0502020204030204" pitchFamily="34" charset="0"/>
              </a:rPr>
              <a:t>capnometry</a:t>
            </a:r>
            <a:endParaRPr 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16200000">
            <a:off x="5056607" y="5006731"/>
            <a:ext cx="165737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Absolute bias </a:t>
            </a:r>
          </a:p>
          <a:p>
            <a:pPr algn="ctr"/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between radar and ECG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308268" y="6706784"/>
            <a:ext cx="21625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RR measured </a:t>
            </a:r>
            <a:r>
              <a:rPr lang="en-US" sz="1200" dirty="0" smtClean="0">
                <a:latin typeface="Calibri" panose="020F0502020204030204" pitchFamily="34" charset="0"/>
                <a:cs typeface="Calibri" panose="020F0502020204030204" pitchFamily="34" charset="0"/>
              </a:rPr>
              <a:t>using </a:t>
            </a:r>
            <a:r>
              <a:rPr lang="en-US" sz="1200" dirty="0" err="1" smtClean="0">
                <a:latin typeface="Calibri" panose="020F0502020204030204" pitchFamily="34" charset="0"/>
                <a:cs typeface="Calibri" panose="020F0502020204030204" pitchFamily="34" charset="0"/>
              </a:rPr>
              <a:t>capnometry</a:t>
            </a:r>
            <a:endParaRPr 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7688371" y="6706784"/>
            <a:ext cx="16734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HR measured using ECG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039338" y="7368104"/>
            <a:ext cx="9436711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 smtClean="0">
                <a:latin typeface="times" panose="02020603050405020304" pitchFamily="18" charset="0"/>
                <a:cs typeface="times" panose="02020603050405020304" pitchFamily="18" charset="0"/>
              </a:rPr>
              <a:t>Supplementary figure 1. Linear regression models for absolute biases with restrictive cubic spline fit for RRs and HRs measured using the conventional methods.</a:t>
            </a:r>
          </a:p>
          <a:p>
            <a:r>
              <a:rPr lang="en-US" altLang="ko-KR" sz="1100" dirty="0" smtClean="0">
                <a:latin typeface="times" panose="02020603050405020304" pitchFamily="18" charset="0"/>
                <a:cs typeface="times" panose="02020603050405020304" pitchFamily="18" charset="0"/>
              </a:rPr>
              <a:t>Absolute biases of RR decreased as RRs measured using </a:t>
            </a:r>
            <a:r>
              <a:rPr lang="en-US" altLang="ko-KR" sz="1100" dirty="0" err="1" smtClean="0">
                <a:latin typeface="times" panose="02020603050405020304" pitchFamily="18" charset="0"/>
                <a:cs typeface="times" panose="02020603050405020304" pitchFamily="18" charset="0"/>
              </a:rPr>
              <a:t>capnometry</a:t>
            </a:r>
            <a:r>
              <a:rPr lang="en-US" altLang="ko-KR" sz="1100" dirty="0" smtClean="0">
                <a:latin typeface="times" panose="02020603050405020304" pitchFamily="18" charset="0"/>
                <a:cs typeface="times" panose="02020603050405020304" pitchFamily="18" charset="0"/>
              </a:rPr>
              <a:t> increased until the RRs reached 18 breath/minute then plateau.</a:t>
            </a:r>
          </a:p>
          <a:p>
            <a:r>
              <a:rPr lang="en-US" altLang="ko-KR" sz="1100" dirty="0" smtClean="0">
                <a:latin typeface="times" panose="02020603050405020304" pitchFamily="18" charset="0"/>
                <a:cs typeface="times" panose="02020603050405020304" pitchFamily="18" charset="0"/>
              </a:rPr>
              <a:t>Absolute biases of HR decreased as HRs measured using ECG increased until  the HRs reached 70 bpm then increased again after HRs reached 80 bpm.</a:t>
            </a:r>
          </a:p>
        </p:txBody>
      </p:sp>
    </p:spTree>
    <p:extLst>
      <p:ext uri="{BB962C8B-B14F-4D97-AF65-F5344CB8AC3E}">
        <p14:creationId xmlns:p14="http://schemas.microsoft.com/office/powerpoint/2010/main" val="4672535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58153" y="1010123"/>
            <a:ext cx="1907706" cy="2203200"/>
          </a:xfrm>
          <a:prstGeom prst="rect">
            <a:avLst/>
          </a:prstGeom>
        </p:spPr>
      </p:pic>
      <p:pic>
        <p:nvPicPr>
          <p:cNvPr id="180" name="그림 17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56237" y="5136951"/>
            <a:ext cx="1908000" cy="2203540"/>
          </a:xfrm>
          <a:prstGeom prst="rect">
            <a:avLst/>
          </a:prstGeom>
        </p:spPr>
      </p:pic>
      <p:pic>
        <p:nvPicPr>
          <p:cNvPr id="177" name="그림 17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62967" y="2961752"/>
            <a:ext cx="1908000" cy="2203540"/>
          </a:xfrm>
          <a:prstGeom prst="rect">
            <a:avLst/>
          </a:prstGeom>
        </p:spPr>
      </p:pic>
      <p:pic>
        <p:nvPicPr>
          <p:cNvPr id="171" name="그림 17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064781" y="977793"/>
            <a:ext cx="1908000" cy="2203540"/>
          </a:xfrm>
          <a:prstGeom prst="rect">
            <a:avLst/>
          </a:prstGeom>
        </p:spPr>
      </p:pic>
      <p:pic>
        <p:nvPicPr>
          <p:cNvPr id="149" name="그림 14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650818" y="5127664"/>
            <a:ext cx="1908000" cy="2203540"/>
          </a:xfrm>
          <a:prstGeom prst="rect">
            <a:avLst/>
          </a:prstGeom>
        </p:spPr>
      </p:pic>
      <p:pic>
        <p:nvPicPr>
          <p:cNvPr id="140" name="그림 13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654071" y="2982687"/>
            <a:ext cx="1908000" cy="2203540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 rot="16200000">
            <a:off x="1147043" y="3834826"/>
            <a:ext cx="1051891" cy="38536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952" dirty="0"/>
              <a:t>Absolute bias</a:t>
            </a:r>
          </a:p>
          <a:p>
            <a:pPr algn="ctr"/>
            <a:r>
              <a:rPr lang="en-US" sz="952" dirty="0"/>
              <a:t>(breath/minute)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322134" y="7147153"/>
            <a:ext cx="788999" cy="2205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33" dirty="0"/>
              <a:t>BMI (kg/m</a:t>
            </a:r>
            <a:r>
              <a:rPr lang="en-US" sz="833" baseline="30000" dirty="0"/>
              <a:t>2</a:t>
            </a:r>
            <a:r>
              <a:rPr lang="en-US" sz="833" dirty="0"/>
              <a:t>)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139019" y="6920143"/>
            <a:ext cx="369012" cy="21454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94" dirty="0"/>
              <a:t>&lt;2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2440801" y="6916788"/>
            <a:ext cx="529312" cy="21454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94" dirty="0"/>
              <a:t>20-24.9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2915893" y="6920143"/>
            <a:ext cx="369012" cy="21454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94" dirty="0"/>
              <a:t>≥25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236597" y="4745772"/>
            <a:ext cx="369012" cy="21454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94" dirty="0"/>
              <a:t>&lt;50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2815903" y="4745772"/>
            <a:ext cx="369012" cy="21454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94" dirty="0"/>
              <a:t>≥50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2376520" y="4925953"/>
            <a:ext cx="737702" cy="2205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33" dirty="0"/>
              <a:t>Age (Years)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2275884" y="2731709"/>
            <a:ext cx="299241" cy="21454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794" dirty="0"/>
              <a:t>F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2848521" y="2731709"/>
            <a:ext cx="322039" cy="21454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794" dirty="0"/>
              <a:t>M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2353671" y="2885613"/>
            <a:ext cx="655331" cy="2205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833" dirty="0"/>
              <a:t>Sex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2384977" y="977913"/>
            <a:ext cx="655331" cy="2632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11" dirty="0"/>
              <a:t>RR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4679667" y="2696741"/>
            <a:ext cx="299241" cy="21454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794" dirty="0"/>
              <a:t>F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5269133" y="2696741"/>
            <a:ext cx="322039" cy="21454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794" dirty="0"/>
              <a:t>M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4768790" y="2861803"/>
            <a:ext cx="655331" cy="2205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833" dirty="0"/>
              <a:t>Sex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4648974" y="4732517"/>
            <a:ext cx="369012" cy="21454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94" dirty="0"/>
              <a:t>&lt;50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5232090" y="4732517"/>
            <a:ext cx="369012" cy="21454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94" dirty="0"/>
              <a:t>≥50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4769846" y="4912698"/>
            <a:ext cx="737702" cy="2205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33" dirty="0"/>
              <a:t>Age (Years)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4702903" y="7130274"/>
            <a:ext cx="788999" cy="2205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33" dirty="0"/>
              <a:t>BMI (kg/m</a:t>
            </a:r>
            <a:r>
              <a:rPr lang="en-US" sz="833" baseline="30000" dirty="0"/>
              <a:t>2</a:t>
            </a:r>
            <a:r>
              <a:rPr lang="en-US" sz="833" dirty="0"/>
              <a:t>)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4598388" y="6923367"/>
            <a:ext cx="369012" cy="21454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94" dirty="0"/>
              <a:t>&lt;20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4907790" y="6920012"/>
            <a:ext cx="529312" cy="21454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94" dirty="0"/>
              <a:t>20-24.9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5381927" y="6923367"/>
            <a:ext cx="369012" cy="21454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94" dirty="0"/>
              <a:t>≥25</a:t>
            </a:r>
          </a:p>
        </p:txBody>
      </p:sp>
      <p:sp>
        <p:nvSpPr>
          <p:cNvPr id="71" name="TextBox 70"/>
          <p:cNvSpPr txBox="1"/>
          <p:nvPr/>
        </p:nvSpPr>
        <p:spPr>
          <a:xfrm rot="16200000">
            <a:off x="3409151" y="3964868"/>
            <a:ext cx="1309974" cy="23884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952" dirty="0"/>
              <a:t>Absolute bias (bpm)</a:t>
            </a:r>
          </a:p>
        </p:txBody>
      </p:sp>
      <p:sp>
        <p:nvSpPr>
          <p:cNvPr id="72" name="TextBox 71"/>
          <p:cNvSpPr txBox="1"/>
          <p:nvPr/>
        </p:nvSpPr>
        <p:spPr>
          <a:xfrm rot="16200000">
            <a:off x="3398772" y="6208954"/>
            <a:ext cx="1309974" cy="23884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952" dirty="0"/>
              <a:t>Absolute bias (bpm)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4679667" y="950812"/>
            <a:ext cx="655331" cy="2632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11" dirty="0"/>
              <a:t>HR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2388480" y="1404193"/>
            <a:ext cx="655331" cy="2145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94" dirty="0"/>
              <a:t>P=0.117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2372231" y="3256669"/>
            <a:ext cx="655331" cy="2145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94" dirty="0"/>
              <a:t>P=0.057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2384978" y="5423296"/>
            <a:ext cx="655331" cy="2145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94" dirty="0"/>
              <a:t>P&lt;0.001</a:t>
            </a:r>
          </a:p>
        </p:txBody>
      </p:sp>
      <p:sp>
        <p:nvSpPr>
          <p:cNvPr id="88" name="TextBox 87"/>
          <p:cNvSpPr txBox="1"/>
          <p:nvPr/>
        </p:nvSpPr>
        <p:spPr>
          <a:xfrm>
            <a:off x="4774822" y="1360355"/>
            <a:ext cx="655331" cy="2145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94" dirty="0"/>
              <a:t>P&lt;0.001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4775646" y="3266136"/>
            <a:ext cx="655331" cy="2145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94" dirty="0"/>
              <a:t>P&lt;0.001</a:t>
            </a:r>
          </a:p>
        </p:txBody>
      </p:sp>
      <p:sp>
        <p:nvSpPr>
          <p:cNvPr id="96" name="TextBox 95"/>
          <p:cNvSpPr txBox="1"/>
          <p:nvPr/>
        </p:nvSpPr>
        <p:spPr>
          <a:xfrm>
            <a:off x="4811032" y="5443197"/>
            <a:ext cx="655331" cy="2145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94" dirty="0"/>
              <a:t>P&lt;0.001</a:t>
            </a:r>
          </a:p>
        </p:txBody>
      </p:sp>
      <p:sp>
        <p:nvSpPr>
          <p:cNvPr id="141" name="TextBox 140"/>
          <p:cNvSpPr txBox="1"/>
          <p:nvPr/>
        </p:nvSpPr>
        <p:spPr>
          <a:xfrm>
            <a:off x="1518653" y="1154396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(A)</a:t>
            </a:r>
            <a:endParaRPr lang="ko-KR" altLang="en-US" sz="1100" dirty="0"/>
          </a:p>
        </p:txBody>
      </p:sp>
      <p:sp>
        <p:nvSpPr>
          <p:cNvPr id="142" name="TextBox 141"/>
          <p:cNvSpPr txBox="1"/>
          <p:nvPr/>
        </p:nvSpPr>
        <p:spPr>
          <a:xfrm>
            <a:off x="1532962" y="3148087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(B)</a:t>
            </a:r>
            <a:endParaRPr lang="ko-KR" altLang="en-US" sz="1100" dirty="0"/>
          </a:p>
        </p:txBody>
      </p:sp>
      <p:sp>
        <p:nvSpPr>
          <p:cNvPr id="143" name="TextBox 142"/>
          <p:cNvSpPr txBox="1"/>
          <p:nvPr/>
        </p:nvSpPr>
        <p:spPr>
          <a:xfrm>
            <a:off x="1519879" y="5318964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(C)</a:t>
            </a:r>
            <a:endParaRPr lang="ko-KR" altLang="en-US" sz="1100" dirty="0"/>
          </a:p>
        </p:txBody>
      </p:sp>
      <p:sp>
        <p:nvSpPr>
          <p:cNvPr id="147" name="TextBox 146"/>
          <p:cNvSpPr txBox="1"/>
          <p:nvPr/>
        </p:nvSpPr>
        <p:spPr>
          <a:xfrm>
            <a:off x="6682822" y="1241190"/>
            <a:ext cx="5015568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>
                <a:latin typeface="times" panose="02020603050405020304" pitchFamily="18" charset="0"/>
                <a:cs typeface="times" panose="02020603050405020304" pitchFamily="18" charset="0"/>
              </a:rPr>
              <a:t>Supplementary figure </a:t>
            </a:r>
            <a:r>
              <a:rPr lang="en-US" altLang="ko-KR" sz="1100" dirty="0" smtClean="0">
                <a:latin typeface="times" panose="02020603050405020304" pitchFamily="18" charset="0"/>
                <a:cs typeface="times" panose="02020603050405020304" pitchFamily="18" charset="0"/>
              </a:rPr>
              <a:t>2. </a:t>
            </a:r>
            <a:r>
              <a:rPr lang="en-US" altLang="ko-KR" sz="1100" dirty="0">
                <a:latin typeface="times" panose="02020603050405020304" pitchFamily="18" charset="0"/>
                <a:cs typeface="times" panose="02020603050405020304" pitchFamily="18" charset="0"/>
              </a:rPr>
              <a:t>Comparisons of absolute biases between the radar and the conventional monitor according to sex, age and BMI.</a:t>
            </a:r>
          </a:p>
          <a:p>
            <a:r>
              <a:rPr lang="en-US" altLang="ko-KR" sz="1100" dirty="0">
                <a:latin typeface="times" panose="02020603050405020304" pitchFamily="18" charset="0"/>
                <a:cs typeface="times" panose="02020603050405020304" pitchFamily="18" charset="0"/>
              </a:rPr>
              <a:t>A, B, C represent the absolute bias levels in </a:t>
            </a:r>
            <a:r>
              <a:rPr lang="en-US" altLang="ko-KR" sz="1100" dirty="0" smtClean="0">
                <a:latin typeface="times" panose="02020603050405020304" pitchFamily="18" charset="0"/>
                <a:cs typeface="times" panose="02020603050405020304" pitchFamily="18" charset="0"/>
              </a:rPr>
              <a:t>RRs and HRs according to sex, age and BMI, respectively. Absolute </a:t>
            </a:r>
            <a:r>
              <a:rPr lang="en-US" altLang="ko-KR" sz="1100" dirty="0">
                <a:latin typeface="times" panose="02020603050405020304" pitchFamily="18" charset="0"/>
                <a:cs typeface="times" panose="02020603050405020304" pitchFamily="18" charset="0"/>
              </a:rPr>
              <a:t>biases </a:t>
            </a:r>
            <a:r>
              <a:rPr lang="en-US" altLang="ko-KR" sz="1100" dirty="0" smtClean="0">
                <a:latin typeface="times" panose="02020603050405020304" pitchFamily="18" charset="0"/>
                <a:cs typeface="times" panose="02020603050405020304" pitchFamily="18" charset="0"/>
              </a:rPr>
              <a:t>of RRs were lower in the </a:t>
            </a:r>
            <a:r>
              <a:rPr lang="en-US" altLang="ko-KR" sz="1100" dirty="0">
                <a:latin typeface="times" panose="02020603050405020304" pitchFamily="18" charset="0"/>
                <a:cs typeface="times" panose="02020603050405020304" pitchFamily="18" charset="0"/>
              </a:rPr>
              <a:t>BMI ≥25 </a:t>
            </a:r>
            <a:r>
              <a:rPr lang="en-US" altLang="ko-KR" sz="1100" dirty="0" smtClean="0">
                <a:latin typeface="times" panose="02020603050405020304" pitchFamily="18" charset="0"/>
                <a:cs typeface="times" panose="02020603050405020304" pitchFamily="18" charset="0"/>
              </a:rPr>
              <a:t>kg/m</a:t>
            </a:r>
            <a:r>
              <a:rPr lang="en-US" altLang="ko-KR" sz="1100" baseline="30000" dirty="0" smtClean="0">
                <a:latin typeface="times" panose="02020603050405020304" pitchFamily="18" charset="0"/>
                <a:cs typeface="times" panose="02020603050405020304" pitchFamily="18" charset="0"/>
              </a:rPr>
              <a:t>2</a:t>
            </a:r>
            <a:r>
              <a:rPr lang="en-US" altLang="ko-KR" sz="1100" dirty="0" smtClean="0">
                <a:latin typeface="times" panose="02020603050405020304" pitchFamily="18" charset="0"/>
                <a:cs typeface="times" panose="02020603050405020304" pitchFamily="18" charset="0"/>
              </a:rPr>
              <a:t>, whereas absolute biases of HRs </a:t>
            </a:r>
            <a:r>
              <a:rPr lang="en-US" altLang="ko-KR" sz="1100" dirty="0">
                <a:latin typeface="times" panose="02020603050405020304" pitchFamily="18" charset="0"/>
                <a:cs typeface="times" panose="02020603050405020304" pitchFamily="18" charset="0"/>
              </a:rPr>
              <a:t>are greater in male, in </a:t>
            </a:r>
            <a:r>
              <a:rPr lang="en-US" altLang="ko-KR" sz="1100" dirty="0" smtClean="0">
                <a:latin typeface="times" panose="02020603050405020304" pitchFamily="18" charset="0"/>
                <a:cs typeface="times" panose="02020603050405020304" pitchFamily="18" charset="0"/>
              </a:rPr>
              <a:t>patients </a:t>
            </a:r>
            <a:r>
              <a:rPr lang="en-US" altLang="ko-KR" sz="1100" dirty="0">
                <a:latin typeface="times" panose="02020603050405020304" pitchFamily="18" charset="0"/>
                <a:cs typeface="times" panose="02020603050405020304" pitchFamily="18" charset="0"/>
              </a:rPr>
              <a:t>≥50 years and in those with BMI ≥25 kg/m</a:t>
            </a:r>
            <a:r>
              <a:rPr lang="en-US" altLang="ko-KR" sz="1100" baseline="30000" dirty="0">
                <a:latin typeface="times" panose="02020603050405020304" pitchFamily="18" charset="0"/>
                <a:cs typeface="times" panose="02020603050405020304" pitchFamily="18" charset="0"/>
              </a:rPr>
              <a:t>2</a:t>
            </a:r>
            <a:r>
              <a:rPr lang="en-US" altLang="ko-KR" sz="1100" dirty="0">
                <a:latin typeface="times" panose="02020603050405020304" pitchFamily="18" charset="0"/>
                <a:cs typeface="times" panose="02020603050405020304" pitchFamily="18" charset="0"/>
              </a:rPr>
              <a:t> in both the supine and the sitting positions.</a:t>
            </a:r>
          </a:p>
        </p:txBody>
      </p:sp>
      <p:sp>
        <p:nvSpPr>
          <p:cNvPr id="151" name="TextBox 150"/>
          <p:cNvSpPr txBox="1"/>
          <p:nvPr/>
        </p:nvSpPr>
        <p:spPr>
          <a:xfrm rot="16200000">
            <a:off x="3442211" y="1904963"/>
            <a:ext cx="1309974" cy="23884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952" dirty="0"/>
              <a:t>Absolute bias (bpm)</a:t>
            </a:r>
          </a:p>
        </p:txBody>
      </p:sp>
      <p:sp>
        <p:nvSpPr>
          <p:cNvPr id="152" name="TextBox 151"/>
          <p:cNvSpPr txBox="1"/>
          <p:nvPr/>
        </p:nvSpPr>
        <p:spPr>
          <a:xfrm rot="16200000">
            <a:off x="1147042" y="6046039"/>
            <a:ext cx="1051891" cy="38536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952" dirty="0"/>
              <a:t>Absolute bias</a:t>
            </a:r>
          </a:p>
          <a:p>
            <a:pPr algn="ctr"/>
            <a:r>
              <a:rPr lang="en-US" sz="952" dirty="0"/>
              <a:t>(breath/minute)</a:t>
            </a:r>
          </a:p>
        </p:txBody>
      </p:sp>
      <p:sp>
        <p:nvSpPr>
          <p:cNvPr id="153" name="TextBox 152"/>
          <p:cNvSpPr txBox="1"/>
          <p:nvPr/>
        </p:nvSpPr>
        <p:spPr>
          <a:xfrm rot="16200000">
            <a:off x="1147043" y="1831705"/>
            <a:ext cx="1051891" cy="38536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952" dirty="0"/>
              <a:t>Absolute bias</a:t>
            </a:r>
          </a:p>
          <a:p>
            <a:pPr algn="ctr"/>
            <a:r>
              <a:rPr lang="en-US" sz="952" dirty="0"/>
              <a:t>(breath/minute)</a:t>
            </a:r>
          </a:p>
        </p:txBody>
      </p:sp>
    </p:spTree>
    <p:extLst>
      <p:ext uri="{BB962C8B-B14F-4D97-AF65-F5344CB8AC3E}">
        <p14:creationId xmlns:p14="http://schemas.microsoft.com/office/powerpoint/2010/main" val="40489462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548</TotalTime>
  <Words>280</Words>
  <Application>Microsoft Office PowerPoint</Application>
  <PresentationFormat>사용자 지정</PresentationFormat>
  <Paragraphs>55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8" baseType="lpstr">
      <vt:lpstr>맑은 고딕</vt:lpstr>
      <vt:lpstr>Arial</vt:lpstr>
      <vt:lpstr>Calibri</vt:lpstr>
      <vt:lpstr>Calibri Light</vt:lpstr>
      <vt:lpstr>times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박준영</dc:creator>
  <cp:lastModifiedBy>박준영</cp:lastModifiedBy>
  <cp:revision>338</cp:revision>
  <dcterms:created xsi:type="dcterms:W3CDTF">2020-07-24T12:38:12Z</dcterms:created>
  <dcterms:modified xsi:type="dcterms:W3CDTF">2021-08-02T10:38:45Z</dcterms:modified>
</cp:coreProperties>
</file>